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086" y="4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883371"/>
            <a:ext cx="144780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RVI data with personal identifiers sent</a:t>
            </a:r>
          </a:p>
          <a:p>
            <a:pPr algn="ctr"/>
            <a:r>
              <a:rPr lang="fr-BE" sz="1200" dirty="0" smtClean="0">
                <a:latin typeface="Arial" pitchFamily="34" charset="0"/>
                <a:cs typeface="Arial" pitchFamily="34" charset="0"/>
              </a:rPr>
              <a:t>to HILMO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124200" y="975705"/>
            <a:ext cx="18288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Search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database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person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identifiers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and ICD-10 code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703124" y="772953"/>
            <a:ext cx="2362200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1200" dirty="0" smtClean="0">
                <a:latin typeface="Arial" pitchFamily="34" charset="0"/>
                <a:cs typeface="Arial" pitchFamily="34" charset="0"/>
              </a:rPr>
              <a:t>Listing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search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results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sent back to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medically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qualifi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investigator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person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identifier,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diagnosis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, date of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diagnosis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name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of the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hospit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)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38200" y="3124198"/>
            <a:ext cx="1600200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Database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clean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potenti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NOAD cases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review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by GSK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safety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physicia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38200" y="4862208"/>
            <a:ext cx="160020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1200" dirty="0" smtClean="0">
                <a:latin typeface="Arial" pitchFamily="34" charset="0"/>
                <a:cs typeface="Arial" pitchFamily="34" charset="0"/>
              </a:rPr>
              <a:t>Data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analyz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by an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extern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statisticia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38500" y="3124199"/>
            <a:ext cx="16002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Potenti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NOAD cases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encod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clinic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database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715000" y="2908131"/>
            <a:ext cx="2362200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1200" dirty="0" smtClean="0">
                <a:latin typeface="Arial" pitchFamily="34" charset="0"/>
                <a:cs typeface="Arial" pitchFamily="34" charset="0"/>
              </a:rPr>
              <a:t>Listing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review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by a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medically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qualifi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person</a:t>
            </a:r>
            <a:endParaRPr lang="fr-BE" sz="1200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Medical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paper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retrieved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from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hospitals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to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confirm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diagnosis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and date of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disease</a:t>
            </a:r>
            <a:r>
              <a:rPr lang="fr-BE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BE" sz="1200" dirty="0" err="1" smtClean="0">
                <a:latin typeface="Arial" pitchFamily="34" charset="0"/>
                <a:cs typeface="Arial" pitchFamily="34" charset="0"/>
              </a:rPr>
              <a:t>onset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2514600" y="1280784"/>
            <a:ext cx="4191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5105400" y="1295278"/>
            <a:ext cx="4191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6904512" y="2163783"/>
            <a:ext cx="0" cy="381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5040828" y="3448005"/>
            <a:ext cx="419100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2638548" y="3448005"/>
            <a:ext cx="419100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1638300" y="4267200"/>
            <a:ext cx="0" cy="381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0" y="5842337"/>
            <a:ext cx="914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.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ssiv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gistry-linked safety surveillance for new-onset autoimmune diseases (NOADs)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VI, Registry of Vaccinated Individuals; HILMO, Care Register for Social Welfare and Health Care; ICD-10, International Classification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seases-10. ICD-1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des of potential immune-mediated diseases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IMD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in HILMO. On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IMD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new onset after study start were considered as NOAD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60161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2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arshini S</dc:creator>
  <cp:lastModifiedBy>Stéphanie Delval</cp:lastModifiedBy>
  <cp:revision>19</cp:revision>
  <dcterms:created xsi:type="dcterms:W3CDTF">2006-08-16T00:00:00Z</dcterms:created>
  <dcterms:modified xsi:type="dcterms:W3CDTF">2015-11-18T14:30:45Z</dcterms:modified>
</cp:coreProperties>
</file>